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F19EBE-046F-DE14-A7C0-7D246A4C1A5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59041FB-C7AA-2268-A02F-E06BF90BB41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E7A4C3-D12A-75E7-69A2-969879E28F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ED68C-6837-4C65-B0FF-19752325BA50}" type="datetimeFigureOut">
              <a:rPr lang="en-US" smtClean="0"/>
              <a:t>2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8913CA-D41F-12E4-52DF-F3898F4706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4902A1-BC18-208C-BB07-FFF8049725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B24C3-3F3F-48F6-80AD-8758A35BE6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72960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48EFC1-97F4-5EE9-413D-ADBFF9370D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474046A-6BD8-0910-C852-3F800EE64C2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82E150-8E7D-413D-7257-C1611ACC68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ED68C-6837-4C65-B0FF-19752325BA50}" type="datetimeFigureOut">
              <a:rPr lang="en-US" smtClean="0"/>
              <a:t>2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1ECB7C-94D9-9878-2EE8-77F70399EF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B70A0F-17C4-9B4C-EC24-59C16AFE38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B24C3-3F3F-48F6-80AD-8758A35BE6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8613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14DF414-6CEB-CDD8-99C7-FE055915824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C8EC622-DD1B-3BE7-E7CE-BAD70A6141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27B603-C0E0-4EE7-1EEF-4395350760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ED68C-6837-4C65-B0FF-19752325BA50}" type="datetimeFigureOut">
              <a:rPr lang="en-US" smtClean="0"/>
              <a:t>2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429A20-50F2-6FD1-B0C0-FE7FDBE585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02CB96-1B0A-644B-A594-5C5399678A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B24C3-3F3F-48F6-80AD-8758A35BE6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60007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9760A2-0025-EB6B-5B03-F22190ABEC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B3AA350-66E9-EAF0-32A7-EEEE3FB723A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5F75D6-A8BA-6803-D612-A15E32D8C5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ED68C-6837-4C65-B0FF-19752325BA50}" type="datetimeFigureOut">
              <a:rPr lang="en-US" smtClean="0"/>
              <a:t>2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EE77B2-B3F5-F120-F2AE-9B6F0C0419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8973CE-8B9C-318E-48A2-3E0D1D7A94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B24C3-3F3F-48F6-80AD-8758A35BE6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58365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197479-6F6C-C717-238A-DB479E449D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B3EC6D-8F8B-652E-16C9-ECC3E6351A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BF3DE5-CB91-4388-217B-24CC90AA70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ED68C-6837-4C65-B0FF-19752325BA50}" type="datetimeFigureOut">
              <a:rPr lang="en-US" smtClean="0"/>
              <a:t>2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C51680-0589-7FEF-CD4F-D8DC4B72F4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D9EAEA-D93F-D889-8594-4273898E01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B24C3-3F3F-48F6-80AD-8758A35BE6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72341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5BB3FF-F564-19BA-FB60-ECB289C6EC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3BFE55-F33F-B253-2F4A-8AC114412B9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709A40F-8AD5-461B-A61C-AD0CFB3845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7CB52F-8344-9CA1-B7E0-9050420211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ED68C-6837-4C65-B0FF-19752325BA50}" type="datetimeFigureOut">
              <a:rPr lang="en-US" smtClean="0"/>
              <a:t>2/1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D56DDA-C959-4BC4-556C-BCDE136826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D0F8EC-5DBE-B0F0-4CB8-450534AF5B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B24C3-3F3F-48F6-80AD-8758A35BE6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12125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4F3B24-9D0D-0081-848F-F40A8C6D91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E54806-F246-6612-A1E1-CD3BFC6C1C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8E9B2B0-33D4-CBA7-742D-9550FA8385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2C5E772-CBFD-29D0-06D5-9A0150C3B54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BE37496-EF0C-F31F-4C12-6F9D69A7EB8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43D6B9D-C27D-B6E8-66AC-7506996445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ED68C-6837-4C65-B0FF-19752325BA50}" type="datetimeFigureOut">
              <a:rPr lang="en-US" smtClean="0"/>
              <a:t>2/14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683E613-1A7F-1D9F-384E-CE4F30CAF3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E4693A5-6774-2329-8477-FDC5D0F068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B24C3-3F3F-48F6-80AD-8758A35BE6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31370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FEF177-9358-5AC0-1FA7-5C0A49C2DC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24B4D40-8BF5-5EDA-9458-85A9C3C0D4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ED68C-6837-4C65-B0FF-19752325BA50}" type="datetimeFigureOut">
              <a:rPr lang="en-US" smtClean="0"/>
              <a:t>2/14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42C744F-32E3-1609-F325-0430EC86E5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D297D40-3F4C-5947-BF82-79E01F8DA8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B24C3-3F3F-48F6-80AD-8758A35BE6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6424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68886F3-4724-EA62-E968-6BC359765C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ED68C-6837-4C65-B0FF-19752325BA50}" type="datetimeFigureOut">
              <a:rPr lang="en-US" smtClean="0"/>
              <a:t>2/14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73FA65A-76F2-A4AE-50E5-E7FBCB5750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986B280-C1FE-736C-FF37-EA2C788C70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B24C3-3F3F-48F6-80AD-8758A35BE6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2703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A1A07E-FCE1-5184-B8D6-AF07EE6B70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48A1AB-82F3-FEB7-0F7C-1BE4D7470D8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82F96ED-3FF1-1765-EBD5-C3E10DB54F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C73D7F-7DB3-CD04-6F46-03FBA40A1D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ED68C-6837-4C65-B0FF-19752325BA50}" type="datetimeFigureOut">
              <a:rPr lang="en-US" smtClean="0"/>
              <a:t>2/1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A5EC2F1-E47A-0FB8-F3C0-A82CD19F6D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087E31-E30F-54B5-6323-6DE24231B6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B24C3-3F3F-48F6-80AD-8758A35BE6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05036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223E44-61C5-A3CD-4692-BB1F0F2044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73E9DA8-91B3-D08A-E304-8941028638C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C6101B0-33E9-BF06-01A2-2CC47DAA9A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C38EDFD-89B5-B9F0-0016-740FED05ED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ED68C-6837-4C65-B0FF-19752325BA50}" type="datetimeFigureOut">
              <a:rPr lang="en-US" smtClean="0"/>
              <a:t>2/1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F0C6425-8EBF-749C-8251-28A3C581BC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5B8E26F-7FD3-7940-84A0-68B8FFBB8E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B24C3-3F3F-48F6-80AD-8758A35BE6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1818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01395D0-F56B-05FC-6F91-5D3965A29C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76DBB8-7286-FD66-F546-3B0509A0E0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D52359-239B-3215-E577-5D53263D0C9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2ED68C-6837-4C65-B0FF-19752325BA50}" type="datetimeFigureOut">
              <a:rPr lang="en-US" smtClean="0"/>
              <a:t>2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F48875-2F5D-932A-E09D-3BE8AE7E148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CC6E37-C5B9-2BF1-8138-AE171796D5A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BB24C3-3F3F-48F6-80AD-8758A35BE6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64367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0E451504-F0E3-EF14-6953-657E94BC7C96}"/>
              </a:ext>
            </a:extLst>
          </p:cNvPr>
          <p:cNvSpPr txBox="1"/>
          <p:nvPr/>
        </p:nvSpPr>
        <p:spPr>
          <a:xfrm>
            <a:off x="1228366" y="691042"/>
            <a:ext cx="10423941" cy="9682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1. 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enes of interest in H versus B/T. Comparative analysis of KRAS, TP53, SMAD4, CDKN2A onco-genes in both primary tumor origins after NGS. Abbreviations: head (H), body/tail (B/T), next generation sequencing (NGS)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869D75BC-7E4D-BD3A-931E-45B7E282BC2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54694375"/>
              </p:ext>
            </p:extLst>
          </p:nvPr>
        </p:nvGraphicFramePr>
        <p:xfrm>
          <a:off x="1846729" y="5591839"/>
          <a:ext cx="8498542" cy="763903"/>
        </p:xfrm>
        <a:graphic>
          <a:graphicData uri="http://schemas.openxmlformats.org/drawingml/2006/table">
            <a:tbl>
              <a:tblPr/>
              <a:tblGrid>
                <a:gridCol w="1258834">
                  <a:extLst>
                    <a:ext uri="{9D8B030D-6E8A-4147-A177-3AD203B41FA5}">
                      <a16:colId xmlns:a16="http://schemas.microsoft.com/office/drawing/2014/main" val="3741743111"/>
                    </a:ext>
                  </a:extLst>
                </a:gridCol>
                <a:gridCol w="963972">
                  <a:extLst>
                    <a:ext uri="{9D8B030D-6E8A-4147-A177-3AD203B41FA5}">
                      <a16:colId xmlns:a16="http://schemas.microsoft.com/office/drawing/2014/main" val="2868636208"/>
                    </a:ext>
                  </a:extLst>
                </a:gridCol>
                <a:gridCol w="986654">
                  <a:extLst>
                    <a:ext uri="{9D8B030D-6E8A-4147-A177-3AD203B41FA5}">
                      <a16:colId xmlns:a16="http://schemas.microsoft.com/office/drawing/2014/main" val="872730895"/>
                    </a:ext>
                  </a:extLst>
                </a:gridCol>
                <a:gridCol w="896376">
                  <a:extLst>
                    <a:ext uri="{9D8B030D-6E8A-4147-A177-3AD203B41FA5}">
                      <a16:colId xmlns:a16="http://schemas.microsoft.com/office/drawing/2014/main" val="1470620508"/>
                    </a:ext>
                  </a:extLst>
                </a:gridCol>
                <a:gridCol w="986118">
                  <a:extLst>
                    <a:ext uri="{9D8B030D-6E8A-4147-A177-3AD203B41FA5}">
                      <a16:colId xmlns:a16="http://schemas.microsoft.com/office/drawing/2014/main" val="146247610"/>
                    </a:ext>
                  </a:extLst>
                </a:gridCol>
                <a:gridCol w="1030941">
                  <a:extLst>
                    <a:ext uri="{9D8B030D-6E8A-4147-A177-3AD203B41FA5}">
                      <a16:colId xmlns:a16="http://schemas.microsoft.com/office/drawing/2014/main" val="2292368197"/>
                    </a:ext>
                  </a:extLst>
                </a:gridCol>
                <a:gridCol w="959224">
                  <a:extLst>
                    <a:ext uri="{9D8B030D-6E8A-4147-A177-3AD203B41FA5}">
                      <a16:colId xmlns:a16="http://schemas.microsoft.com/office/drawing/2014/main" val="933501950"/>
                    </a:ext>
                  </a:extLst>
                </a:gridCol>
                <a:gridCol w="735106">
                  <a:extLst>
                    <a:ext uri="{9D8B030D-6E8A-4147-A177-3AD203B41FA5}">
                      <a16:colId xmlns:a16="http://schemas.microsoft.com/office/drawing/2014/main" val="3058767282"/>
                    </a:ext>
                  </a:extLst>
                </a:gridCol>
                <a:gridCol w="681317">
                  <a:extLst>
                    <a:ext uri="{9D8B030D-6E8A-4147-A177-3AD203B41FA5}">
                      <a16:colId xmlns:a16="http://schemas.microsoft.com/office/drawing/2014/main" val="3748355945"/>
                    </a:ext>
                  </a:extLst>
                </a:gridCol>
              </a:tblGrid>
              <a:tr h="177163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es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itive (Head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gative (Head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(Head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itive (Body/Tail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gative (Body/Tail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(Body/Tail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-valu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37430228"/>
                  </a:ext>
                </a:extLst>
              </a:tr>
              <a:tr h="94487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GS-KRA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.2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.9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8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1412310"/>
                  </a:ext>
                </a:extLst>
              </a:tr>
              <a:tr h="94487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GS-TP5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.7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.3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6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78408694"/>
                  </a:ext>
                </a:extLst>
              </a:tr>
              <a:tr h="94487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GS-SMAD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4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.2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.8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5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37188552"/>
                  </a:ext>
                </a:extLst>
              </a:tr>
              <a:tr h="94487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GS-CDKN2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.3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.7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6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57734213"/>
                  </a:ext>
                </a:extLst>
              </a:tr>
            </a:tbl>
          </a:graphicData>
        </a:graphic>
      </p:graphicFrame>
      <p:pic>
        <p:nvPicPr>
          <p:cNvPr id="3" name="Picture 2">
            <a:extLst>
              <a:ext uri="{FF2B5EF4-FFF2-40B4-BE49-F238E27FC236}">
                <a16:creationId xmlns:a16="http://schemas.microsoft.com/office/drawing/2014/main" id="{EBCEBCF1-92EA-39BD-A357-031714D81DC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0488" b="3175"/>
          <a:stretch/>
        </p:blipFill>
        <p:spPr>
          <a:xfrm>
            <a:off x="3439108" y="1931452"/>
            <a:ext cx="5313783" cy="35209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422710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17669958-49BB-F57A-ADD7-915B3DC741A8}"/>
              </a:ext>
            </a:extLst>
          </p:cNvPr>
          <p:cNvSpPr txBox="1"/>
          <p:nvPr/>
        </p:nvSpPr>
        <p:spPr>
          <a:xfrm>
            <a:off x="1933041" y="512859"/>
            <a:ext cx="9400485" cy="67191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2. 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usions (WTS) in pancreatic H vs. B/T primary tumors. Abbreviations: head (H), body/tail (B/T), next-generation sequencing (NGS). 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34CD7C6C-8DE6-82B3-E1DA-60F92451BDE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85356876"/>
              </p:ext>
            </p:extLst>
          </p:nvPr>
        </p:nvGraphicFramePr>
        <p:xfrm>
          <a:off x="2037831" y="5392769"/>
          <a:ext cx="8219159" cy="880110"/>
        </p:xfrm>
        <a:graphic>
          <a:graphicData uri="http://schemas.openxmlformats.org/drawingml/2006/table">
            <a:tbl>
              <a:tblPr/>
              <a:tblGrid>
                <a:gridCol w="1073264">
                  <a:extLst>
                    <a:ext uri="{9D8B030D-6E8A-4147-A177-3AD203B41FA5}">
                      <a16:colId xmlns:a16="http://schemas.microsoft.com/office/drawing/2014/main" val="2294345776"/>
                    </a:ext>
                  </a:extLst>
                </a:gridCol>
                <a:gridCol w="821869">
                  <a:extLst>
                    <a:ext uri="{9D8B030D-6E8A-4147-A177-3AD203B41FA5}">
                      <a16:colId xmlns:a16="http://schemas.microsoft.com/office/drawing/2014/main" val="3944972027"/>
                    </a:ext>
                  </a:extLst>
                </a:gridCol>
                <a:gridCol w="841207">
                  <a:extLst>
                    <a:ext uri="{9D8B030D-6E8A-4147-A177-3AD203B41FA5}">
                      <a16:colId xmlns:a16="http://schemas.microsoft.com/office/drawing/2014/main" val="3210637900"/>
                    </a:ext>
                  </a:extLst>
                </a:gridCol>
                <a:gridCol w="1044257">
                  <a:extLst>
                    <a:ext uri="{9D8B030D-6E8A-4147-A177-3AD203B41FA5}">
                      <a16:colId xmlns:a16="http://schemas.microsoft.com/office/drawing/2014/main" val="2371795957"/>
                    </a:ext>
                  </a:extLst>
                </a:gridCol>
                <a:gridCol w="937540">
                  <a:extLst>
                    <a:ext uri="{9D8B030D-6E8A-4147-A177-3AD203B41FA5}">
                      <a16:colId xmlns:a16="http://schemas.microsoft.com/office/drawing/2014/main" val="1460417244"/>
                    </a:ext>
                  </a:extLst>
                </a:gridCol>
                <a:gridCol w="984653">
                  <a:extLst>
                    <a:ext uri="{9D8B030D-6E8A-4147-A177-3AD203B41FA5}">
                      <a16:colId xmlns:a16="http://schemas.microsoft.com/office/drawing/2014/main" val="521626915"/>
                    </a:ext>
                  </a:extLst>
                </a:gridCol>
                <a:gridCol w="1131279">
                  <a:extLst>
                    <a:ext uri="{9D8B030D-6E8A-4147-A177-3AD203B41FA5}">
                      <a16:colId xmlns:a16="http://schemas.microsoft.com/office/drawing/2014/main" val="3962980184"/>
                    </a:ext>
                  </a:extLst>
                </a:gridCol>
                <a:gridCol w="754185">
                  <a:extLst>
                    <a:ext uri="{9D8B030D-6E8A-4147-A177-3AD203B41FA5}">
                      <a16:colId xmlns:a16="http://schemas.microsoft.com/office/drawing/2014/main" val="1308219284"/>
                    </a:ext>
                  </a:extLst>
                </a:gridCol>
                <a:gridCol w="630905">
                  <a:extLst>
                    <a:ext uri="{9D8B030D-6E8A-4147-A177-3AD203B41FA5}">
                      <a16:colId xmlns:a16="http://schemas.microsoft.com/office/drawing/2014/main" val="745443858"/>
                    </a:ext>
                  </a:extLst>
                </a:gridCol>
              </a:tblGrid>
              <a:tr h="118783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es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itive (Head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gative (Head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(Head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itive (Body/Tail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gative (Body/Tail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(Body/Tail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-valu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18253874"/>
                  </a:ext>
                </a:extLst>
              </a:tr>
              <a:tr h="118783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nscriptome-NRG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2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7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10827712"/>
                  </a:ext>
                </a:extLst>
              </a:tr>
              <a:tr h="118783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nscriptome-FGFR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2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7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61252097"/>
                  </a:ext>
                </a:extLst>
              </a:tr>
              <a:tr h="118783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nscriptome-PRKC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2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29338485"/>
                  </a:ext>
                </a:extLst>
              </a:tr>
              <a:tr h="118783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nscriptome-BRAF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2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64276172"/>
                  </a:ext>
                </a:extLst>
              </a:tr>
              <a:tr h="118783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nscriptome-ALK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2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0%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1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8609249"/>
                  </a:ext>
                </a:extLst>
              </a:tr>
            </a:tbl>
          </a:graphicData>
        </a:graphic>
      </p:graphicFrame>
      <p:pic>
        <p:nvPicPr>
          <p:cNvPr id="3" name="Picture 2">
            <a:extLst>
              <a:ext uri="{FF2B5EF4-FFF2-40B4-BE49-F238E27FC236}">
                <a16:creationId xmlns:a16="http://schemas.microsoft.com/office/drawing/2014/main" id="{53E1BF24-43BC-1B29-69EB-EDD3B6DEDC7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0428" b="2922"/>
          <a:stretch/>
        </p:blipFill>
        <p:spPr>
          <a:xfrm>
            <a:off x="3247869" y="1576237"/>
            <a:ext cx="6009290" cy="37055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66271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CCA7564-B9A6-9DEF-60CA-1A1A822D2333}"/>
              </a:ext>
            </a:extLst>
          </p:cNvPr>
          <p:cNvSpPr txBox="1"/>
          <p:nvPr/>
        </p:nvSpPr>
        <p:spPr>
          <a:xfrm>
            <a:off x="2384570" y="779778"/>
            <a:ext cx="8554673" cy="67191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3. 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ercent &gt;0 in H vs B/T  primary tumors.</a:t>
            </a:r>
            <a:r>
              <a:rPr lang="en-US" sz="18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bbreviations: head (H), body/tail (B/T)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E1AC8F89-5C2F-85A8-7A06-1C22E408676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185" t="50000"/>
          <a:stretch/>
        </p:blipFill>
        <p:spPr>
          <a:xfrm>
            <a:off x="7159240" y="1815709"/>
            <a:ext cx="2886011" cy="353088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0DC0114-7592-61FF-C177-12E7B0CB1C36}"/>
              </a:ext>
            </a:extLst>
          </p:cNvPr>
          <p:cNvSpPr txBox="1"/>
          <p:nvPr/>
        </p:nvSpPr>
        <p:spPr>
          <a:xfrm>
            <a:off x="6789908" y="2741074"/>
            <a:ext cx="369332" cy="165038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200" dirty="0"/>
              <a:t>Immune cell infiltration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BE75662-14C3-28A1-7A2D-2B0FB6F0831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7371" b="3019"/>
          <a:stretch/>
        </p:blipFill>
        <p:spPr>
          <a:xfrm>
            <a:off x="1962142" y="2062148"/>
            <a:ext cx="4827766" cy="31597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397341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screenshot of a graph&#10;&#10;Description automatically generated">
            <a:extLst>
              <a:ext uri="{FF2B5EF4-FFF2-40B4-BE49-F238E27FC236}">
                <a16:creationId xmlns:a16="http://schemas.microsoft.com/office/drawing/2014/main" id="{DF473A08-676A-3E72-67DF-02C9428EB59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211" t="12821" r="54808" b="45584"/>
          <a:stretch/>
        </p:blipFill>
        <p:spPr bwMode="auto">
          <a:xfrm>
            <a:off x="2713882" y="2723162"/>
            <a:ext cx="5438775" cy="315658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D9481FD-D77A-98FB-3763-2CD67A52E290}"/>
              </a:ext>
            </a:extLst>
          </p:cNvPr>
          <p:cNvSpPr txBox="1"/>
          <p:nvPr/>
        </p:nvSpPr>
        <p:spPr>
          <a:xfrm>
            <a:off x="947956" y="625660"/>
            <a:ext cx="10888910" cy="126464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Table 1.</a:t>
            </a:r>
            <a:r>
              <a:rPr lang="en-US" sz="16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 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edian units are shown for the TIME.  Where median values were “0”, the percent of nonzero values are shown.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 primary tumors, M2 macrophages and Neutrophils were significantly more abundant in pancreatic H than in B/T. M1 macrophages were significantly more abundant in B/T than in pancreatic H. NK and Endothelial cells trended higher in pancreatic H than in B/T. Red: higher median value; Blue: lower median value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703435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379</Words>
  <Application>Microsoft Office PowerPoint</Application>
  <PresentationFormat>Widescreen</PresentationFormat>
  <Paragraphs>10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Houston Methodis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smail, Abdullah</dc:creator>
  <cp:lastModifiedBy>Esmail, Abdullah</cp:lastModifiedBy>
  <cp:revision>2</cp:revision>
  <dcterms:created xsi:type="dcterms:W3CDTF">2024-02-14T21:27:38Z</dcterms:created>
  <dcterms:modified xsi:type="dcterms:W3CDTF">2024-02-14T21:34:10Z</dcterms:modified>
</cp:coreProperties>
</file>